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773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6FAEB7-91B6-9951-4CA7-11D046D3827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E11A55-9580-3CEC-C46C-FE29D178EE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7DFFDE9-A0B8-0A9D-9F7F-067D1CFFE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C56F9BE-8AEE-BDDF-4E26-919979138A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662B33-9393-A372-92A8-7F940102F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8187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DF25937-BC74-906D-A740-DB7D9B5D0E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45D8A89-DF28-1110-2219-E05C0825DE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16574DB-8D9D-AA2A-DAF3-8E7D5C79A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882B26-F6A7-82C2-AE08-996511F3B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8ABC38-D628-7777-624A-CECB453C8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733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646D3C0-2C32-273D-8764-A4881D7A0C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E810DD1-A99E-BA59-4D62-06F60ABBB6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8DA0F3-AF73-7935-DB67-8DC920540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DE93BC0-1050-3455-0FD6-B2DCFF88B9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175CF4-D3A3-CBD1-1CB1-F238E57CB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99145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3C55E4-A139-643D-762C-96C58EF3D4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1A6B510-A8D4-ECFA-679E-ABE4A28C70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51C3D4-0131-4597-5778-CB3756852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2E56B46-FA21-8F6B-24F9-2E517875F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9F6117-82DD-24F1-6BC3-5F1BE369A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1003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F3EBA9-A0B8-E831-4490-5B6EE8F6F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B0788CB-9BD5-5695-EDB2-24C2350E6B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F852B5-8E2C-87D1-C1C8-62766A4C1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EC66D2-06B9-F21A-E2B3-B32330E1DE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932FCB8-3D0A-4058-CD45-8E80E54F4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942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BA4C9E-18F0-6906-3409-08E20A1CF1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B7C8BA1-8112-EC9E-0915-9CC01C8B23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67B3799-8301-EF3B-1B9A-BC784227EC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6F218CD-C89D-659B-AFC2-07F2D3CDF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AC5C92-DAA6-D12A-96A3-9AAFC6B37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E74C79C-D7B1-74D3-56C6-8D56A3955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0146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21E0AA-A71F-369B-21BB-3E6F71C6CC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F5DF7D-BA2F-BA5A-89B8-D08D3A267A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4960999-B85D-3296-7F2F-535BBFAC65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D36C4F2-1535-AE0B-807B-1E84A948A3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D3B90F4-E43F-895A-902E-EC85083796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CA72FA2-E22A-9A4E-92D7-1CF665F1A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144D167-4FF8-94AA-14F6-8259D5FA3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3FCFF70D-F2CB-0B8D-7CA1-4D29AD8D2A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2238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51647C-6790-A7B6-0F7B-3815D39986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67FF064-A52E-CA8C-E9B5-01178B08B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932D299-3A83-46A3-BA76-56720D92B3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B620A1A-D27B-E5E8-52B7-D33B6BB07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1152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13E15FC-A521-7C6A-96DF-BA1A2A218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4FF4221-149D-FEBB-EBBE-B840A214E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4665E9C-6329-9728-D64F-62B545399B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767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094FC4-118A-8EDB-B4D1-505EF881B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1D3C8CD-56AC-D7D8-CC60-537A836A7A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323614D-72C3-B42A-2E08-C32D7B2D8E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E2F95B9-C1DD-3A71-D944-867BFC5FE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CBC6EE1-0676-5445-7778-FF47075CA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4BE4C71-A927-83EF-669F-3E545E8B1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596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274F607-F78D-E163-FA6D-83C1BF71F9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E281561-97DE-6E3E-6F81-AFA9817ED8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F3657F1-44AD-2740-D791-E5303289A6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63769F3-4FF1-3290-B4B5-D4C5A88AC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BB6657-C752-BEE6-3035-57EB5FB02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ADC318D-2D0A-DA71-8E46-E80FA039A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358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0D81498-EE9E-8DE2-6461-019D04D01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D033DEF-EB54-A49A-20F4-2AF4630FEB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518741-6C58-9068-701C-1298F9E2823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A8D26-2A42-4669-9168-8B262A49BEF1}" type="datetimeFigureOut">
              <a:rPr kumimoji="1" lang="ja-JP" altLang="en-US" smtClean="0"/>
              <a:t>2024/6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471FD17-F990-1E5C-5613-3CC05A5794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AA4142-34C4-91E4-46AC-99E0493092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49A199-7603-4536-B775-054AE59726B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844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21D9AC-7DF6-9A93-C2AF-F2DF70F203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0" y="5701553"/>
            <a:ext cx="12192000" cy="1156444"/>
          </a:xfrm>
        </p:spPr>
        <p:txBody>
          <a:bodyPr>
            <a:norm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800" b="1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</a:t>
            </a:r>
            <a:r>
              <a:rPr lang="ja-JP" altLang="en-US" sz="1800" b="1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8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Temporal variation of the water phantom temperature and atmospheric pressure in the treatment room.</a:t>
            </a:r>
            <a:endParaRPr lang="ja-JP" altLang="ja-JP" sz="1800" b="1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1AB10FD2-ACD1-D569-295B-BEDF015A9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1353800" cy="970383"/>
          </a:xfrm>
        </p:spPr>
        <p:txBody>
          <a:bodyPr/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75E178CC-BB50-366D-B12F-B7285F761A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702" y="1488140"/>
            <a:ext cx="8845018" cy="4078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6684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19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游明朝</vt:lpstr>
      <vt:lpstr>Arial</vt:lpstr>
      <vt:lpstr>Office テーマ</vt:lpstr>
      <vt:lpstr>FIGURE S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山中 将史</dc:creator>
  <cp:lastModifiedBy>将史 山中</cp:lastModifiedBy>
  <cp:revision>37</cp:revision>
  <dcterms:created xsi:type="dcterms:W3CDTF">2023-07-04T01:56:08Z</dcterms:created>
  <dcterms:modified xsi:type="dcterms:W3CDTF">2024-06-23T05:08:56Z</dcterms:modified>
</cp:coreProperties>
</file>